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sldIdLst>
    <p:sldId id="256" r:id="rId2"/>
  </p:sldIdLst>
  <p:sldSz cx="6858000" cy="114728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328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877620"/>
            <a:ext cx="5829300" cy="39942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025910"/>
            <a:ext cx="5143500" cy="276995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2917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7039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10824"/>
            <a:ext cx="1478756" cy="972272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10824"/>
            <a:ext cx="4350544" cy="972272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3136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729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860252"/>
            <a:ext cx="5915025" cy="477239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677792"/>
            <a:ext cx="5915025" cy="250968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144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054119"/>
            <a:ext cx="2914650" cy="72794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054119"/>
            <a:ext cx="2914650" cy="72794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3728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10826"/>
            <a:ext cx="5915025" cy="221755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812446"/>
            <a:ext cx="2901255" cy="137833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190782"/>
            <a:ext cx="2901255" cy="61640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812446"/>
            <a:ext cx="2915543" cy="137833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190782"/>
            <a:ext cx="2915543" cy="61640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3877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2382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456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64858"/>
            <a:ext cx="2211884" cy="267700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651882"/>
            <a:ext cx="3471863" cy="815316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441859"/>
            <a:ext cx="2211884" cy="637646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6355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64858"/>
            <a:ext cx="2211884" cy="267700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651882"/>
            <a:ext cx="3471863" cy="815316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441859"/>
            <a:ext cx="2211884" cy="637646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083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10826"/>
            <a:ext cx="5915025" cy="221755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054119"/>
            <a:ext cx="5915025" cy="72794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0633647"/>
            <a:ext cx="1543050" cy="6108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61E13B-F592-460E-8CD5-5F5DBAA8B7BC}" type="datetimeFigureOut">
              <a:rPr lang="en-GB" smtClean="0"/>
              <a:t>0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0633647"/>
            <a:ext cx="2314575" cy="6108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0633647"/>
            <a:ext cx="1543050" cy="6108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CB7CE3-354A-4DF8-92FD-AB503336D3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6098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Normal Top View">
            <a:hlinkClick r:id="" action="ppaction://media"/>
            <a:extLst>
              <a:ext uri="{FF2B5EF4-FFF2-40B4-BE49-F238E27FC236}">
                <a16:creationId xmlns:a16="http://schemas.microsoft.com/office/drawing/2014/main" id="{5BDB46C2-A83D-4573-889F-C22FF2F37CD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648511" y="1430052"/>
            <a:ext cx="3536263" cy="2652197"/>
          </a:xfrm>
          <a:prstGeom prst="rect">
            <a:avLst/>
          </a:prstGeom>
        </p:spPr>
      </p:pic>
      <p:sp>
        <p:nvSpPr>
          <p:cNvPr id="48" name="Text Box 124">
            <a:extLst>
              <a:ext uri="{FF2B5EF4-FFF2-40B4-BE49-F238E27FC236}">
                <a16:creationId xmlns:a16="http://schemas.microsoft.com/office/drawing/2014/main" id="{FFB671EC-63EB-415B-B81C-4C5DF485F2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4451" y="7675889"/>
            <a:ext cx="5284381" cy="854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51435" tIns="25718" rIns="51435" bIns="25718" anchor="t" anchorCtr="0">
            <a:spAutoFit/>
          </a:bodyPr>
          <a:lstStyle/>
          <a:p>
            <a:pPr algn="just">
              <a:lnSpc>
                <a:spcPct val="150000"/>
              </a:lnSpc>
              <a:spcAft>
                <a:spcPts val="45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asal Cilia brushing diagnostics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High speed video microscopy top view showing normal cilia beat in control sample (A) and showing rotational cilia beat pattern in individual II:1 from family 5 (B). </a:t>
            </a:r>
          </a:p>
        </p:txBody>
      </p:sp>
      <p:sp>
        <p:nvSpPr>
          <p:cNvPr id="77" name="Text Box 83">
            <a:extLst>
              <a:ext uri="{FF2B5EF4-FFF2-40B4-BE49-F238E27FC236}">
                <a16:creationId xmlns:a16="http://schemas.microsoft.com/office/drawing/2014/main" id="{4D02640A-6EA3-477F-BEB6-66FCA5B367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1890" y="1163352"/>
            <a:ext cx="495300" cy="266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8" name="Text Box 2">
            <a:extLst>
              <a:ext uri="{FF2B5EF4-FFF2-40B4-BE49-F238E27FC236}">
                <a16:creationId xmlns:a16="http://schemas.microsoft.com/office/drawing/2014/main" id="{3160AE9B-D680-46F0-A0AA-83A3557A53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1890" y="4273643"/>
            <a:ext cx="495300" cy="266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Figure 3 patient video">
            <a:hlinkClick r:id="" action="ppaction://media"/>
            <a:extLst>
              <a:ext uri="{FF2B5EF4-FFF2-40B4-BE49-F238E27FC236}">
                <a16:creationId xmlns:a16="http://schemas.microsoft.com/office/drawing/2014/main" id="{7544FB0D-E107-47B3-9FDC-B6787AC543F2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648511" y="5012253"/>
            <a:ext cx="3536263" cy="19891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29697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499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033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</TotalTime>
  <Words>50</Words>
  <Application>Microsoft Office PowerPoint</Application>
  <PresentationFormat>Custom</PresentationFormat>
  <Paragraphs>3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eming Andrew</dc:creator>
  <cp:lastModifiedBy>Ferlin Anna</cp:lastModifiedBy>
  <cp:revision>10</cp:revision>
  <dcterms:created xsi:type="dcterms:W3CDTF">2023-04-28T15:49:26Z</dcterms:created>
  <dcterms:modified xsi:type="dcterms:W3CDTF">2023-07-03T13:01:20Z</dcterms:modified>
</cp:coreProperties>
</file>